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3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9999"/>
    <a:srgbClr val="FF5050"/>
    <a:srgbClr val="D60093"/>
    <a:srgbClr val="FF00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2860E05-B656-47D3-93A2-C96C681B6FC5}" v="1" dt="2023-02-13T11:43:32.047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D7AC3CCA-C797-4891-BE02-D94E43425B78}" styleName="スタイル (中間)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755" autoAdjust="0"/>
    <p:restoredTop sz="93490" autoAdjust="0"/>
  </p:normalViewPr>
  <p:slideViewPr>
    <p:cSldViewPr>
      <p:cViewPr varScale="1">
        <p:scale>
          <a:sx n="107" d="100"/>
          <a:sy n="107" d="100"/>
        </p:scale>
        <p:origin x="93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69514B2-EBAE-4B2A-AEDA-FA164F52A2A6}" type="datetimeFigureOut">
              <a:rPr kumimoji="1" lang="ja-JP" altLang="en-US" smtClean="0"/>
              <a:t>2023/8/2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584AB11-012B-4916-9F24-096E669E9B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76393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CC66298-B618-9399-DA56-7C2DD3C9FE7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F047AD8B-2B71-AE37-B07D-3C154351AF7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8FDC04E-1F23-CFC4-4DF1-7E6FC1FF5B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6B09E0-A2EC-42E1-97D6-C22FDDA216AC}" type="datetimeFigureOut">
              <a:rPr kumimoji="1" lang="ja-JP" altLang="en-US" smtClean="0"/>
              <a:t>2023/8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730C445-4FC5-8C48-B791-7D3C490AB0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2AB6009-AEDD-6AA2-515B-C21A1134AB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4206DF-E322-4E88-ABA2-AC6E363447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04499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C8BB8B2-CA1A-7976-1D68-A5A4E35AFB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0F9CACE-82C3-0B5A-59EC-09A48264E00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DB418DA-D6A8-E5B2-41A2-1B79182F71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6B09E0-A2EC-42E1-97D6-C22FDDA216AC}" type="datetimeFigureOut">
              <a:rPr kumimoji="1" lang="ja-JP" altLang="en-US" smtClean="0"/>
              <a:t>2023/8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8F826DF-C10C-3758-71F6-1257CA54FD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165CA34-E89D-6BC7-0FF6-9FB2D4E643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4206DF-E322-4E88-ABA2-AC6E363447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82283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180DCE2E-F776-3710-1E0F-7060B4C3FFC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6C4DDF40-AB3F-EF46-55F2-94E36A8BBA6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B09A1FB-D1AF-092B-25C4-18CF571D69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6B09E0-A2EC-42E1-97D6-C22FDDA216AC}" type="datetimeFigureOut">
              <a:rPr kumimoji="1" lang="ja-JP" altLang="en-US" smtClean="0"/>
              <a:t>2023/8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E716553-901A-1F45-4C31-68042EFB56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58B1F24-7E26-8E42-ECF6-1CF1CD9EF7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4206DF-E322-4E88-ABA2-AC6E363447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99669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5F0C9CC-8062-B6CA-993D-9F84BAC94E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4C98982-7672-3466-0635-01FD078221D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B3BF316-B94D-6F67-32EC-F124EA638A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6B09E0-A2EC-42E1-97D6-C22FDDA216AC}" type="datetimeFigureOut">
              <a:rPr kumimoji="1" lang="ja-JP" altLang="en-US" smtClean="0"/>
              <a:t>2023/8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16BD491-FCAF-C0EC-8F7C-76E7DBB7CD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DDFB521-0749-045D-AD0F-1CB003D224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4206DF-E322-4E88-ABA2-AC6E363447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09393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FA28A90-5D78-04CF-A013-1CAB0AC885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E7B776D-13E4-5F67-5541-AC2090AD44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77011A7-6612-F20D-2521-A2ACF4036C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6B09E0-A2EC-42E1-97D6-C22FDDA216AC}" type="datetimeFigureOut">
              <a:rPr kumimoji="1" lang="ja-JP" altLang="en-US" smtClean="0"/>
              <a:t>2023/8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354034D-C98B-EDDF-2EC1-C9A48E56C9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7358331-3BF6-A675-0142-5523D30C5F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4206DF-E322-4E88-ABA2-AC6E363447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95080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1253C8D-F0B0-68A6-87B3-C9F76A08D6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85FBBDB-9783-6240-826E-65DFB4F067C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9669E49-D121-3468-93BC-D793DD0DC67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4FC1CDF-2364-C888-C28F-E441EFBFDB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6B09E0-A2EC-42E1-97D6-C22FDDA216AC}" type="datetimeFigureOut">
              <a:rPr kumimoji="1" lang="ja-JP" altLang="en-US" smtClean="0"/>
              <a:t>2023/8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5A3167E-4FD0-FFF9-A331-AB8A19B163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DAB4913-9C2C-F320-F69A-99851C2A8E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4206DF-E322-4E88-ABA2-AC6E363447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12540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6621487-161E-4C6E-CF01-5F8012CB5F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A2DF396-F221-E418-7FF1-2DBCE4D786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4E170BB-6014-95FD-78D2-F2D1958F917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152C754D-B2DD-1585-59F2-E6C706F85EC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A3A628B1-D00E-B7B3-9B3F-AE374220A2D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1A0F2B2B-6072-CAE1-74FC-D62E664B83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6B09E0-A2EC-42E1-97D6-C22FDDA216AC}" type="datetimeFigureOut">
              <a:rPr kumimoji="1" lang="ja-JP" altLang="en-US" smtClean="0"/>
              <a:t>2023/8/2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BBFD6957-7CE3-183F-C45C-9BAF5C11FE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008C6BF8-E686-76A0-9983-49C9926261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4206DF-E322-4E88-ABA2-AC6E363447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5030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36A430A-B8BB-FB1D-7DA3-827390D2D5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3A2D196D-588A-FDA9-A9FD-C0717031D5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6B09E0-A2EC-42E1-97D6-C22FDDA216AC}" type="datetimeFigureOut">
              <a:rPr kumimoji="1" lang="ja-JP" altLang="en-US" smtClean="0"/>
              <a:t>2023/8/2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07CB5DE1-99CF-053F-EEE3-557C4D22FB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CF177C9D-D4CA-7888-B444-87EF41A4A4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4206DF-E322-4E88-ABA2-AC6E363447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13784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6B9EB3E4-53AB-4E32-1648-83AB6AAACD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6B09E0-A2EC-42E1-97D6-C22FDDA216AC}" type="datetimeFigureOut">
              <a:rPr kumimoji="1" lang="ja-JP" altLang="en-US" smtClean="0"/>
              <a:t>2023/8/2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AF680576-410D-6AE7-4D49-AF235B2BDE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086131C9-D416-4B1D-A13C-6E27DCE700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4206DF-E322-4E88-ABA2-AC6E363447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8199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B6BB9CA-1B4E-F220-A2B0-38FCA171CD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0A7591D-C78F-7BB8-31E9-5EF8CC41821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385C266-08EE-D275-C279-23729C09FB7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7E57463-7998-5E35-1769-CAEAAFADD5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6B09E0-A2EC-42E1-97D6-C22FDDA216AC}" type="datetimeFigureOut">
              <a:rPr kumimoji="1" lang="ja-JP" altLang="en-US" smtClean="0"/>
              <a:t>2023/8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500DC08-C832-49F3-63EC-2DA033DA98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DC6E330-33FF-8B95-9BB5-38A7106EB8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4206DF-E322-4E88-ABA2-AC6E363447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47799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B6C7FED-2C84-0768-03D6-BF5FDCE296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1BDB270D-0C39-D6DD-9AA1-B34A135319E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645E805-A1A1-E512-DCB7-EF17A93546C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FC280E9-0C28-E3E3-B8CF-CF955EDF84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6B09E0-A2EC-42E1-97D6-C22FDDA216AC}" type="datetimeFigureOut">
              <a:rPr kumimoji="1" lang="ja-JP" altLang="en-US" smtClean="0"/>
              <a:t>2023/8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870A55A-2C8C-9AA1-C9BB-BF4E1BCFA7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9457B4F-3E6A-906F-A9C8-0973C0A7D1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4206DF-E322-4E88-ABA2-AC6E363447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35185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D182CD97-68EB-1E63-5305-2E47016DD3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460ECBD-FC00-0204-644A-0F0494CDC8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08C7AA1-9E48-AE1B-8FE5-B07F8B5F528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6B09E0-A2EC-42E1-97D6-C22FDDA216AC}" type="datetimeFigureOut">
              <a:rPr kumimoji="1" lang="ja-JP" altLang="en-US" smtClean="0"/>
              <a:t>2023/8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7A44D09-A1D1-0C48-057A-E346F3372E9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8978D15-E578-FDF7-09A7-F179DD7A644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4206DF-E322-4E88-ABA2-AC6E363447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44673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2">
            <a:extLst>
              <a:ext uri="{FF2B5EF4-FFF2-40B4-BE49-F238E27FC236}">
                <a16:creationId xmlns:a16="http://schemas.microsoft.com/office/drawing/2014/main" id="{86B69F2C-D2B1-FE23-EE74-E92ADD3482F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07273510"/>
              </p:ext>
            </p:extLst>
          </p:nvPr>
        </p:nvGraphicFramePr>
        <p:xfrm>
          <a:off x="767407" y="2312876"/>
          <a:ext cx="10657186" cy="2232248"/>
        </p:xfrm>
        <a:graphic>
          <a:graphicData uri="http://schemas.openxmlformats.org/drawingml/2006/table">
            <a:tbl>
              <a:tblPr firstRow="1" bandRow="1">
                <a:tableStyleId>{D7AC3CCA-C797-4891-BE02-D94E43425B78}</a:tableStyleId>
              </a:tblPr>
              <a:tblGrid>
                <a:gridCol w="3456384">
                  <a:extLst>
                    <a:ext uri="{9D8B030D-6E8A-4147-A177-3AD203B41FA5}">
                      <a16:colId xmlns:a16="http://schemas.microsoft.com/office/drawing/2014/main" val="3613447613"/>
                    </a:ext>
                  </a:extLst>
                </a:gridCol>
                <a:gridCol w="3600401">
                  <a:extLst>
                    <a:ext uri="{9D8B030D-6E8A-4147-A177-3AD203B41FA5}">
                      <a16:colId xmlns:a16="http://schemas.microsoft.com/office/drawing/2014/main" val="2255870154"/>
                    </a:ext>
                  </a:extLst>
                </a:gridCol>
                <a:gridCol w="3600401">
                  <a:extLst>
                    <a:ext uri="{9D8B030D-6E8A-4147-A177-3AD203B41FA5}">
                      <a16:colId xmlns:a16="http://schemas.microsoft.com/office/drawing/2014/main" val="4037353200"/>
                    </a:ext>
                  </a:extLst>
                </a:gridCol>
              </a:tblGrid>
              <a:tr h="864096">
                <a:tc>
                  <a:txBody>
                    <a:bodyPr/>
                    <a:lstStyle/>
                    <a:p>
                      <a:pPr algn="ctr"/>
                      <a:endParaRPr kumimoji="1" lang="ja-JP" altLang="en-US" sz="18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+mn-ea"/>
                        </a:rPr>
                        <a:t>MUC5AC or MUC6 (+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+mn-ea"/>
                        </a:rPr>
                        <a:t>MUC5AC and MUC6 (-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66351617"/>
                  </a:ext>
                </a:extLst>
              </a:tr>
              <a:tr h="684076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+mn-ea"/>
                        </a:rPr>
                        <a:t>MUC2 or CD10 (+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+mn-ea"/>
                        </a:rPr>
                        <a:t>Gastrointestinal phenotype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+mn-ea"/>
                        </a:rPr>
                        <a:t>Intestinal phenotype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50378623"/>
                  </a:ext>
                </a:extLst>
              </a:tr>
              <a:tr h="684076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+mn-ea"/>
                        </a:rPr>
                        <a:t>MUC2 and CD10 (-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>
                          <a:solidFill>
                            <a:sysClr val="windowText" lastClr="000000"/>
                          </a:solidFill>
                        </a:rPr>
                        <a:t>Gastric phenotype</a:t>
                      </a:r>
                      <a:endParaRPr kumimoji="1" lang="ja-JP" altLang="en-US" sz="18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solidFill>
                            <a:sysClr val="windowText" lastClr="000000"/>
                          </a:solidFill>
                        </a:rPr>
                        <a:t>Unclassified phenotype</a:t>
                      </a:r>
                      <a:endParaRPr kumimoji="1" lang="ja-JP" altLang="en-US" sz="18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32177685"/>
                  </a:ext>
                </a:extLst>
              </a:tr>
            </a:tbl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27D72669-06BB-55D7-155D-B773035A0D84}"/>
              </a:ext>
            </a:extLst>
          </p:cNvPr>
          <p:cNvSpPr txBox="1"/>
          <p:nvPr/>
        </p:nvSpPr>
        <p:spPr>
          <a:xfrm>
            <a:off x="983432" y="836712"/>
            <a:ext cx="6840760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 fontAlgn="ctr"/>
            <a:r>
              <a:rPr lang="en-US" altLang="ja-JP" sz="2000" b="0" i="0" u="none" strike="noStrike" dirty="0">
                <a:solidFill>
                  <a:srgbClr val="000000"/>
                </a:solidFill>
                <a:effectLst/>
                <a:latin typeface="游ゴシック" panose="020B0400000000000000" pitchFamily="50" charset="-128"/>
                <a:ea typeface="游ゴシック" panose="020B0400000000000000" pitchFamily="50" charset="-128"/>
              </a:rPr>
              <a:t>Supplementary Figure S1: Phenotypic classification</a:t>
            </a:r>
          </a:p>
        </p:txBody>
      </p:sp>
    </p:spTree>
    <p:extLst>
      <p:ext uri="{BB962C8B-B14F-4D97-AF65-F5344CB8AC3E}">
        <p14:creationId xmlns:p14="http://schemas.microsoft.com/office/powerpoint/2010/main" val="2496081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Integral</Template>
  <TotalTime>6927</TotalTime>
  <Words>30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鈴木信之</dc:creator>
  <cp:lastModifiedBy>MDPI</cp:lastModifiedBy>
  <cp:revision>21</cp:revision>
  <dcterms:created xsi:type="dcterms:W3CDTF">2022-09-03T06:05:09Z</dcterms:created>
  <dcterms:modified xsi:type="dcterms:W3CDTF">2023-08-22T04:08:22Z</dcterms:modified>
</cp:coreProperties>
</file>